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8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0" autoAdjust="0"/>
    <p:restoredTop sz="94633"/>
  </p:normalViewPr>
  <p:slideViewPr>
    <p:cSldViewPr snapToGrid="0" snapToObjects="1">
      <p:cViewPr varScale="1">
        <p:scale>
          <a:sx n="80" d="100"/>
          <a:sy n="80" d="100"/>
        </p:scale>
        <p:origin x="2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PF2;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8:$F$88</c:f>
                <c:numCache>
                  <c:formatCode>General</c:formatCode>
                  <c:ptCount val="2"/>
                  <c:pt idx="0">
                    <c:v>0.32976950340151462</c:v>
                  </c:pt>
                  <c:pt idx="1">
                    <c:v>0.1805759496091108</c:v>
                  </c:pt>
                </c:numCache>
              </c:numRef>
            </c:plus>
            <c:minus>
              <c:numRef>
                <c:f>log2じゃない方!$E$88:$F$88</c:f>
                <c:numCache>
                  <c:formatCode>General</c:formatCode>
                  <c:ptCount val="2"/>
                  <c:pt idx="0">
                    <c:v>0.32976950340151462</c:v>
                  </c:pt>
                  <c:pt idx="1">
                    <c:v>0.18057594960911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8:$D$88</c:f>
              <c:numCache>
                <c:formatCode>General</c:formatCode>
                <c:ptCount val="2"/>
                <c:pt idx="0">
                  <c:v>2.4671256650090228</c:v>
                </c:pt>
                <c:pt idx="1">
                  <c:v>2.02435983761908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22-4BC8-96C1-FC958CC0A9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CC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2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89:$F$89</c:f>
                <c:numCache>
                  <c:formatCode>General</c:formatCode>
                  <c:ptCount val="2"/>
                  <c:pt idx="0">
                    <c:v>0.14300375268890089</c:v>
                  </c:pt>
                  <c:pt idx="1">
                    <c:v>7.9627810226497953E-2</c:v>
                  </c:pt>
                </c:numCache>
              </c:numRef>
            </c:plus>
            <c:minus>
              <c:numRef>
                <c:f>log2じゃない方!$E$89:$F$89</c:f>
                <c:numCache>
                  <c:formatCode>General</c:formatCode>
                  <c:ptCount val="2"/>
                  <c:pt idx="0">
                    <c:v>0.14300375268890089</c:v>
                  </c:pt>
                  <c:pt idx="1">
                    <c:v>7.962781022649795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89:$D$89</c:f>
              <c:numCache>
                <c:formatCode>General</c:formatCode>
                <c:ptCount val="2"/>
                <c:pt idx="0">
                  <c:v>0.8465776239233217</c:v>
                </c:pt>
                <c:pt idx="1">
                  <c:v>1.0334954152731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3F-4393-A5B2-3A4DC14126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LC2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3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90:$F$90</c:f>
                <c:numCache>
                  <c:formatCode>General</c:formatCode>
                  <c:ptCount val="2"/>
                  <c:pt idx="0">
                    <c:v>5.975536917160755E-2</c:v>
                  </c:pt>
                  <c:pt idx="1">
                    <c:v>3.6961229055398476E-2</c:v>
                  </c:pt>
                </c:numCache>
              </c:numRef>
            </c:plus>
            <c:minus>
              <c:numRef>
                <c:f>log2じゃない方!$E$90:$F$90</c:f>
                <c:numCache>
                  <c:formatCode>General</c:formatCode>
                  <c:ptCount val="2"/>
                  <c:pt idx="0">
                    <c:v>5.975536917160755E-2</c:v>
                  </c:pt>
                  <c:pt idx="1">
                    <c:v>3.696122905539847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90:$D$90</c:f>
              <c:numCache>
                <c:formatCode>General</c:formatCode>
                <c:ptCount val="2"/>
                <c:pt idx="0">
                  <c:v>0.49318129666338928</c:v>
                </c:pt>
                <c:pt idx="1">
                  <c:v>0.330637697245539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4E-4D8B-8AE3-57E56508D2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LC5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91:$F$91</c:f>
                <c:numCache>
                  <c:formatCode>General</c:formatCode>
                  <c:ptCount val="2"/>
                  <c:pt idx="0">
                    <c:v>0.35242576749015769</c:v>
                  </c:pt>
                  <c:pt idx="1">
                    <c:v>0.10501590834514016</c:v>
                  </c:pt>
                </c:numCache>
              </c:numRef>
            </c:plus>
            <c:minus>
              <c:numRef>
                <c:f>log2じゃない方!$E$91:$F$91</c:f>
                <c:numCache>
                  <c:formatCode>General</c:formatCode>
                  <c:ptCount val="2"/>
                  <c:pt idx="0">
                    <c:v>0.35242576749015769</c:v>
                  </c:pt>
                  <c:pt idx="1">
                    <c:v>0.105015908345140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91:$D$91</c:f>
              <c:numCache>
                <c:formatCode>General</c:formatCode>
                <c:ptCount val="2"/>
                <c:pt idx="0">
                  <c:v>1.2711871834142159</c:v>
                </c:pt>
                <c:pt idx="1">
                  <c:v>1.85297121209266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C4-4DA0-9FFA-D3EDB5D606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CLC6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92:$F$92</c:f>
                <c:numCache>
                  <c:formatCode>General</c:formatCode>
                  <c:ptCount val="2"/>
                  <c:pt idx="0">
                    <c:v>0.36477560784634672</c:v>
                  </c:pt>
                  <c:pt idx="1">
                    <c:v>3.465535602105433E-2</c:v>
                  </c:pt>
                </c:numCache>
              </c:numRef>
            </c:plus>
            <c:minus>
              <c:numRef>
                <c:f>log2じゃない方!$E$92:$F$92</c:f>
                <c:numCache>
                  <c:formatCode>General</c:formatCode>
                  <c:ptCount val="2"/>
                  <c:pt idx="0">
                    <c:v>0.36477560784634672</c:v>
                  </c:pt>
                  <c:pt idx="1">
                    <c:v>3.46553560210543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92:$D$92</c:f>
              <c:numCache>
                <c:formatCode>General</c:formatCode>
                <c:ptCount val="2"/>
                <c:pt idx="0">
                  <c:v>2.5683577328473537</c:v>
                </c:pt>
                <c:pt idx="1">
                  <c:v>1.6082229076330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43-48ED-93AC-F0CFAFD06B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SLAH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93:$F$93</c:f>
                <c:numCache>
                  <c:formatCode>General</c:formatCode>
                  <c:ptCount val="2"/>
                  <c:pt idx="0">
                    <c:v>5.5327436928586261E-3</c:v>
                  </c:pt>
                  <c:pt idx="1">
                    <c:v>8.6293758336121983E-3</c:v>
                  </c:pt>
                </c:numCache>
              </c:numRef>
            </c:plus>
            <c:minus>
              <c:numRef>
                <c:f>log2じゃない方!$E$93:$F$93</c:f>
                <c:numCache>
                  <c:formatCode>General</c:formatCode>
                  <c:ptCount val="2"/>
                  <c:pt idx="0">
                    <c:v>5.5327436928586261E-3</c:v>
                  </c:pt>
                  <c:pt idx="1">
                    <c:v>8.629375833612198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93:$D$93</c:f>
              <c:numCache>
                <c:formatCode>General</c:formatCode>
                <c:ptCount val="2"/>
                <c:pt idx="0">
                  <c:v>2.5285557178061222E-2</c:v>
                </c:pt>
                <c:pt idx="1">
                  <c:v>6.805814601395991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78-42E5-B71A-8A8466F255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SLAH7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3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E$94:$F$94</c:f>
                <c:numCache>
                  <c:formatCode>General</c:formatCode>
                  <c:ptCount val="2"/>
                  <c:pt idx="0">
                    <c:v>3.0888555925479583E-3</c:v>
                  </c:pt>
                  <c:pt idx="1">
                    <c:v>1.1896429616092467E-3</c:v>
                  </c:pt>
                </c:numCache>
              </c:numRef>
            </c:plus>
            <c:minus>
              <c:numRef>
                <c:f>log2じゃない方!$E$94:$F$94</c:f>
                <c:numCache>
                  <c:formatCode>General</c:formatCode>
                  <c:ptCount val="2"/>
                  <c:pt idx="0">
                    <c:v>3.0888555925479583E-3</c:v>
                  </c:pt>
                  <c:pt idx="1">
                    <c:v>1.189642961609246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C$94:$D$94</c:f>
              <c:numCache>
                <c:formatCode>General</c:formatCode>
                <c:ptCount val="2"/>
                <c:pt idx="0">
                  <c:v>1.9393823828234524E-2</c:v>
                </c:pt>
                <c:pt idx="1">
                  <c:v>2.45584577437991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13-40A5-8BE4-504FDE2D07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9980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55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1143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142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5772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23528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953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500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63792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37358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1867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7373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27512545-083E-4DAB-99F2-C4D8EC98A8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124992"/>
              </p:ext>
            </p:extLst>
          </p:nvPr>
        </p:nvGraphicFramePr>
        <p:xfrm>
          <a:off x="632555" y="1060114"/>
          <a:ext cx="1938893" cy="1415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769A9450-6F7A-458E-B13E-D64981093E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4661495"/>
              </p:ext>
            </p:extLst>
          </p:nvPr>
        </p:nvGraphicFramePr>
        <p:xfrm>
          <a:off x="2633570" y="1056545"/>
          <a:ext cx="1934496" cy="1415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C4ACA261-2FAA-474A-9847-C56D93B195A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9334180"/>
              </p:ext>
            </p:extLst>
          </p:nvPr>
        </p:nvGraphicFramePr>
        <p:xfrm>
          <a:off x="4619246" y="1056545"/>
          <a:ext cx="1930977" cy="1415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74A6D67F-BE1C-4644-83B3-6613BF99D0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0120984"/>
              </p:ext>
            </p:extLst>
          </p:nvPr>
        </p:nvGraphicFramePr>
        <p:xfrm>
          <a:off x="631128" y="2530366"/>
          <a:ext cx="1947187" cy="1415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BD8BE8AF-A29B-4A2E-8BB4-F6BC9528FBB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1837584"/>
              </p:ext>
            </p:extLst>
          </p:nvPr>
        </p:nvGraphicFramePr>
        <p:xfrm>
          <a:off x="2637300" y="2526871"/>
          <a:ext cx="1934496" cy="1415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3B01F73D-F85A-4487-908A-6686394E1EA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6965036"/>
              </p:ext>
            </p:extLst>
          </p:nvPr>
        </p:nvGraphicFramePr>
        <p:xfrm>
          <a:off x="4619246" y="2526871"/>
          <a:ext cx="1930977" cy="14159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5C7A11F3-013E-4CDE-97FD-394DDB6701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8248306"/>
              </p:ext>
            </p:extLst>
          </p:nvPr>
        </p:nvGraphicFramePr>
        <p:xfrm>
          <a:off x="631128" y="4011194"/>
          <a:ext cx="1938893" cy="14159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FD42F41-4F1A-4DDC-A103-F162C9032055}"/>
              </a:ext>
            </a:extLst>
          </p:cNvPr>
          <p:cNvSpPr txBox="1"/>
          <p:nvPr/>
        </p:nvSpPr>
        <p:spPr>
          <a:xfrm>
            <a:off x="5925681" y="2925808"/>
            <a:ext cx="26212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34">
            <a:extLst>
              <a:ext uri="{FF2B5EF4-FFF2-40B4-BE49-F238E27FC236}">
                <a16:creationId xmlns:a16="http://schemas.microsoft.com/office/drawing/2014/main" id="{7C280F3F-F8F4-AA45-8A00-E4B9C7489FCE}"/>
              </a:ext>
            </a:extLst>
          </p:cNvPr>
          <p:cNvSpPr txBox="1"/>
          <p:nvPr/>
        </p:nvSpPr>
        <p:spPr>
          <a:xfrm>
            <a:off x="1038031" y="2203781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34">
            <a:extLst>
              <a:ext uri="{FF2B5EF4-FFF2-40B4-BE49-F238E27FC236}">
                <a16:creationId xmlns:a16="http://schemas.microsoft.com/office/drawing/2014/main" id="{55FFC468-11D3-7247-8C32-E839674C9B9D}"/>
              </a:ext>
            </a:extLst>
          </p:cNvPr>
          <p:cNvSpPr txBox="1"/>
          <p:nvPr/>
        </p:nvSpPr>
        <p:spPr>
          <a:xfrm>
            <a:off x="3092410" y="2202440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34">
            <a:extLst>
              <a:ext uri="{FF2B5EF4-FFF2-40B4-BE49-F238E27FC236}">
                <a16:creationId xmlns:a16="http://schemas.microsoft.com/office/drawing/2014/main" id="{64A2F10D-15CC-2043-B7A7-59BEDE740DA6}"/>
              </a:ext>
            </a:extLst>
          </p:cNvPr>
          <p:cNvSpPr txBox="1"/>
          <p:nvPr/>
        </p:nvSpPr>
        <p:spPr>
          <a:xfrm>
            <a:off x="5119964" y="2202439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34">
            <a:extLst>
              <a:ext uri="{FF2B5EF4-FFF2-40B4-BE49-F238E27FC236}">
                <a16:creationId xmlns:a16="http://schemas.microsoft.com/office/drawing/2014/main" id="{F68D496D-C633-9E47-AEB3-226BCD9DC1A0}"/>
              </a:ext>
            </a:extLst>
          </p:cNvPr>
          <p:cNvSpPr txBox="1"/>
          <p:nvPr/>
        </p:nvSpPr>
        <p:spPr>
          <a:xfrm>
            <a:off x="1038031" y="369661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34">
            <a:extLst>
              <a:ext uri="{FF2B5EF4-FFF2-40B4-BE49-F238E27FC236}">
                <a16:creationId xmlns:a16="http://schemas.microsoft.com/office/drawing/2014/main" id="{9C5E8460-7B8D-C741-85C4-F0F384968679}"/>
              </a:ext>
            </a:extLst>
          </p:cNvPr>
          <p:cNvSpPr txBox="1"/>
          <p:nvPr/>
        </p:nvSpPr>
        <p:spPr>
          <a:xfrm>
            <a:off x="3092410" y="3696611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34">
            <a:extLst>
              <a:ext uri="{FF2B5EF4-FFF2-40B4-BE49-F238E27FC236}">
                <a16:creationId xmlns:a16="http://schemas.microsoft.com/office/drawing/2014/main" id="{B3004BA5-EBE6-AE4B-AD9F-D1BCA4D5B63D}"/>
              </a:ext>
            </a:extLst>
          </p:cNvPr>
          <p:cNvSpPr txBox="1"/>
          <p:nvPr/>
        </p:nvSpPr>
        <p:spPr>
          <a:xfrm>
            <a:off x="5119964" y="3696610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34">
            <a:extLst>
              <a:ext uri="{FF2B5EF4-FFF2-40B4-BE49-F238E27FC236}">
                <a16:creationId xmlns:a16="http://schemas.microsoft.com/office/drawing/2014/main" id="{DBE4B021-E570-704D-A927-72CFE4C923C8}"/>
              </a:ext>
            </a:extLst>
          </p:cNvPr>
          <p:cNvSpPr txBox="1"/>
          <p:nvPr/>
        </p:nvSpPr>
        <p:spPr>
          <a:xfrm>
            <a:off x="1038031" y="5180934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8BC976B-752A-AA43-81B1-384B1C1BF2C9}"/>
              </a:ext>
            </a:extLst>
          </p:cNvPr>
          <p:cNvSpPr txBox="1"/>
          <p:nvPr/>
        </p:nvSpPr>
        <p:spPr>
          <a:xfrm>
            <a:off x="631128" y="1056546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062C48D-EE5C-1B4C-9E5D-81EE6BF6DF67}"/>
              </a:ext>
            </a:extLst>
          </p:cNvPr>
          <p:cNvSpPr txBox="1"/>
          <p:nvPr/>
        </p:nvSpPr>
        <p:spPr>
          <a:xfrm>
            <a:off x="2623651" y="1056546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4D81414-7FF4-5145-9F80-126134C75E5B}"/>
              </a:ext>
            </a:extLst>
          </p:cNvPr>
          <p:cNvSpPr txBox="1"/>
          <p:nvPr/>
        </p:nvSpPr>
        <p:spPr>
          <a:xfrm>
            <a:off x="4608160" y="1056545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54B0AD3-0DCB-7845-8D8F-9E57E2282DBD}"/>
              </a:ext>
            </a:extLst>
          </p:cNvPr>
          <p:cNvSpPr txBox="1"/>
          <p:nvPr/>
        </p:nvSpPr>
        <p:spPr>
          <a:xfrm>
            <a:off x="631128" y="2532606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C51A02C-0737-1F4D-83E4-20DBAF548468}"/>
              </a:ext>
            </a:extLst>
          </p:cNvPr>
          <p:cNvSpPr txBox="1"/>
          <p:nvPr/>
        </p:nvSpPr>
        <p:spPr>
          <a:xfrm>
            <a:off x="2636364" y="2526871"/>
            <a:ext cx="26321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0E1A05E-6E46-F641-9856-E15472C162D8}"/>
              </a:ext>
            </a:extLst>
          </p:cNvPr>
          <p:cNvSpPr txBox="1"/>
          <p:nvPr/>
        </p:nvSpPr>
        <p:spPr>
          <a:xfrm>
            <a:off x="4622588" y="2526871"/>
            <a:ext cx="25519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41F1121-C7AE-664D-84A7-704382D9DFC0}"/>
              </a:ext>
            </a:extLst>
          </p:cNvPr>
          <p:cNvSpPr txBox="1"/>
          <p:nvPr/>
        </p:nvSpPr>
        <p:spPr>
          <a:xfrm>
            <a:off x="631128" y="4011194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33" name="Text Box 30">
            <a:extLst>
              <a:ext uri="{FF2B5EF4-FFF2-40B4-BE49-F238E27FC236}">
                <a16:creationId xmlns:a16="http://schemas.microsoft.com/office/drawing/2014/main" id="{0C1B906D-A49B-A044-9330-5AACDB72364C}"/>
              </a:ext>
            </a:extLst>
          </p:cNvPr>
          <p:cNvSpPr txBox="1"/>
          <p:nvPr/>
        </p:nvSpPr>
        <p:spPr>
          <a:xfrm rot="16200000">
            <a:off x="-824865" y="2949139"/>
            <a:ext cx="2631440" cy="37237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132080" tIns="66040" rIns="132080" bIns="6604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JP" sz="1200" dirty="0"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Relative expression level</a:t>
            </a:r>
            <a:endParaRPr lang="en-JP" sz="1400" dirty="0"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73601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2</TotalTime>
  <Words>32</Words>
  <Application>Microsoft Office PowerPoint</Application>
  <PresentationFormat>A4 210 x 297 mm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90</cp:revision>
  <cp:lastPrinted>2020-08-12T07:18:28Z</cp:lastPrinted>
  <dcterms:created xsi:type="dcterms:W3CDTF">2020-05-19T13:06:08Z</dcterms:created>
  <dcterms:modified xsi:type="dcterms:W3CDTF">2020-08-13T07:31:33Z</dcterms:modified>
</cp:coreProperties>
</file>